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108" y="1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4984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5059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5840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473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1137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3330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6006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7095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6684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2492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8758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533B0-50B3-477D-AB44-2E5D4C238A40}" type="datetimeFigureOut">
              <a:rPr lang="ko-KR" altLang="en-US" smtClean="0"/>
              <a:t>2021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C3AC72-30FB-4E27-A627-EA44F6D8ED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9033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6822" y="600251"/>
            <a:ext cx="4501977" cy="4386616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6506" y="913517"/>
            <a:ext cx="4160166" cy="3508943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551210" y="5192146"/>
            <a:ext cx="11310592" cy="1512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altLang="ko-KR" sz="16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Schematic diagram for extraction process and the aqueous extract of </a:t>
            </a:r>
            <a:r>
              <a:rPr lang="en-US" altLang="ko-KR" sz="1600" b="1" i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C. fragile </a:t>
            </a:r>
            <a:r>
              <a:rPr lang="en-US" altLang="ko-KR" sz="16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on platelet aggregation.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altLang="ko-KR" sz="16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(A) Schematic diagram for the extraction process of </a:t>
            </a:r>
            <a:r>
              <a:rPr lang="en-US" altLang="ko-KR" sz="1600" i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C. fragile</a:t>
            </a:r>
            <a:r>
              <a:rPr lang="en-US" altLang="ko-KR" sz="16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. (B) Washed mouse platelet were pre-incubated with 100 µg/ml of </a:t>
            </a:r>
            <a:r>
              <a:rPr lang="en-US" altLang="ko-KR" sz="1600" i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C. fragile </a:t>
            </a:r>
            <a:r>
              <a:rPr lang="en-US" altLang="ko-KR" sz="16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aqueous extract for 10 minutes at 37℃ and then stimulated with 0.025 U/ml Thrombin or 2 µg/ml Collagen.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ggregation was measured for 5 minutes at 37°C under constant stirring (1,000 rpm) conditions in a platelet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aggregometer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(Chrono-Log). All data represent the mean ± SD (n = 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). </a:t>
            </a:r>
            <a:endParaRPr lang="en-US" altLang="ko-KR" sz="1600" kern="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284704" y="590945"/>
            <a:ext cx="59503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15874" y="590945"/>
            <a:ext cx="59503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ko-KR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0" y="0"/>
            <a:ext cx="18437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ko-KR" sz="2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31914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pic>
        <p:nvPicPr>
          <p:cNvPr id="1025" name="그림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82" r="16624"/>
          <a:stretch>
            <a:fillRect/>
          </a:stretch>
        </p:blipFill>
        <p:spPr bwMode="auto">
          <a:xfrm rot="-5400000">
            <a:off x="3383280" y="923984"/>
            <a:ext cx="4448175" cy="4048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직사각형 3"/>
          <p:cNvSpPr/>
          <p:nvPr/>
        </p:nvSpPr>
        <p:spPr>
          <a:xfrm>
            <a:off x="3117793" y="5438894"/>
            <a:ext cx="523091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GC spectrum of </a:t>
            </a:r>
            <a:r>
              <a:rPr lang="en-US" altLang="ko-KR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C. fragile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ethanol extract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18437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endParaRPr lang="en-US" altLang="ko-KR" sz="2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97010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/>
          <p:nvPr/>
        </p:nvPicPr>
        <p:blipFill rotWithShape="1">
          <a:blip r:embed="rId2"/>
          <a:srcRect l="4372"/>
          <a:stretch/>
        </p:blipFill>
        <p:spPr bwMode="auto">
          <a:xfrm rot="16200000">
            <a:off x="3280843" y="1021921"/>
            <a:ext cx="5480685" cy="405257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직사각형 2"/>
          <p:cNvSpPr/>
          <p:nvPr/>
        </p:nvSpPr>
        <p:spPr>
          <a:xfrm>
            <a:off x="2466110" y="6020863"/>
            <a:ext cx="7567352" cy="3558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altLang="ko-KR" sz="1600" b="1" kern="1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6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altLang="ko-KR" sz="1600" b="1" kern="100" dirty="0">
                <a:latin typeface="Arial" panose="020B0604020202020204" pitchFamily="34" charset="0"/>
                <a:cs typeface="Arial" panose="020B0604020202020204" pitchFamily="34" charset="0"/>
              </a:rPr>
              <a:t>Identification of major compound in </a:t>
            </a:r>
            <a:r>
              <a:rPr lang="en-US" altLang="ko-KR" sz="1600" b="1" i="1" kern="100" dirty="0">
                <a:latin typeface="Arial" panose="020B0604020202020204" pitchFamily="34" charset="0"/>
                <a:cs typeface="Arial" panose="020B0604020202020204" pitchFamily="34" charset="0"/>
              </a:rPr>
              <a:t>C. fragile </a:t>
            </a:r>
            <a:r>
              <a:rPr lang="en-US" altLang="ko-KR" sz="1600" b="1" kern="100" dirty="0">
                <a:latin typeface="Arial" panose="020B0604020202020204" pitchFamily="34" charset="0"/>
                <a:cs typeface="Arial" panose="020B0604020202020204" pitchFamily="34" charset="0"/>
              </a:rPr>
              <a:t>ethanol extract.</a:t>
            </a:r>
            <a:endParaRPr lang="ko-KR" altLang="ko-KR" sz="16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18437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endParaRPr lang="en-US" altLang="ko-KR" sz="2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5297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39</Words>
  <Application>Microsoft Office PowerPoint</Application>
  <PresentationFormat>와이드스크린</PresentationFormat>
  <Paragraphs>9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5</cp:revision>
  <dcterms:created xsi:type="dcterms:W3CDTF">2021-05-04T00:53:10Z</dcterms:created>
  <dcterms:modified xsi:type="dcterms:W3CDTF">2021-05-10T07:11:13Z</dcterms:modified>
</cp:coreProperties>
</file>